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8" r:id="rId3"/>
    <p:sldId id="267" r:id="rId4"/>
    <p:sldId id="264" r:id="rId5"/>
    <p:sldId id="259" r:id="rId6"/>
    <p:sldId id="265" r:id="rId7"/>
    <p:sldId id="261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35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00487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60361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5133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764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5816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7512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3410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49573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7656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73052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4129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2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6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3588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00FD6-6784-43B3-82A0-37C09D6613C8}" type="datetimeFigureOut">
              <a:rPr lang="en-CA" smtClean="0"/>
              <a:t>2015-02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ADC2D-0511-4CCB-8465-6129EE8104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009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2602523"/>
              </p:ext>
            </p:extLst>
          </p:nvPr>
        </p:nvGraphicFramePr>
        <p:xfrm>
          <a:off x="683568" y="1424970"/>
          <a:ext cx="76962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/>
                <a:gridCol w="1600200"/>
                <a:gridCol w="2400300"/>
                <a:gridCol w="24003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Library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Read Length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Rep</a:t>
                      </a:r>
                      <a:r>
                        <a:rPr lang="en-CA" baseline="0" dirty="0" smtClean="0"/>
                        <a:t> 1 No. pairs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Rep 2 No. pairs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Normal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90 </a:t>
                      </a:r>
                      <a:r>
                        <a:rPr lang="en-CA" dirty="0" err="1" smtClean="0"/>
                        <a:t>bp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42,550,644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42,399,373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FR</a:t>
                      </a:r>
                      <a:r>
                        <a:rPr lang="en-CA" baseline="0" dirty="0" smtClean="0"/>
                        <a:t> day 2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90 </a:t>
                      </a:r>
                      <a:r>
                        <a:rPr lang="en-CA" dirty="0" err="1" smtClean="0"/>
                        <a:t>bp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55,802,571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55,386,373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R day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90 </a:t>
                      </a:r>
                      <a:r>
                        <a:rPr lang="en-CA" dirty="0" err="1" smtClean="0"/>
                        <a:t>bp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42,818,512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42,610,245</a:t>
                      </a:r>
                      <a:endParaRPr lang="en-CA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79512" y="1352962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(a)</a:t>
            </a:r>
            <a:endParaRPr lang="en-CA" dirty="0"/>
          </a:p>
        </p:txBody>
      </p:sp>
      <p:sp>
        <p:nvSpPr>
          <p:cNvPr id="4" name="TextBox 3"/>
          <p:cNvSpPr txBox="1"/>
          <p:nvPr/>
        </p:nvSpPr>
        <p:spPr>
          <a:xfrm>
            <a:off x="467544" y="5106670"/>
            <a:ext cx="8218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600" dirty="0" smtClean="0"/>
              <a:t>Table </a:t>
            </a:r>
            <a:r>
              <a:rPr lang="en-CA" sz="1600" dirty="0" smtClean="0"/>
              <a:t>S2. </a:t>
            </a:r>
            <a:r>
              <a:rPr lang="en-CA" sz="1600" dirty="0" smtClean="0"/>
              <a:t>(a) Whole-genome </a:t>
            </a:r>
            <a:r>
              <a:rPr lang="en-CA" sz="1600" dirty="0" err="1"/>
              <a:t>bisulfite</a:t>
            </a:r>
            <a:r>
              <a:rPr lang="en-CA" sz="1600" dirty="0"/>
              <a:t> sequencing DNA </a:t>
            </a:r>
            <a:r>
              <a:rPr lang="en-CA" sz="1600" dirty="0" smtClean="0"/>
              <a:t>libraries and (b) </a:t>
            </a:r>
            <a:r>
              <a:rPr lang="en-CA" sz="1600" dirty="0" err="1" smtClean="0"/>
              <a:t>sRNA</a:t>
            </a:r>
            <a:r>
              <a:rPr lang="en-CA" sz="1600" dirty="0" smtClean="0"/>
              <a:t> </a:t>
            </a:r>
            <a:r>
              <a:rPr lang="en-CA" sz="1600" dirty="0"/>
              <a:t>sequencing libraries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3581932"/>
              </p:ext>
            </p:extLst>
          </p:nvPr>
        </p:nvGraphicFramePr>
        <p:xfrm>
          <a:off x="683568" y="3335278"/>
          <a:ext cx="60960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/>
                <a:gridCol w="2400300"/>
                <a:gridCol w="24003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Library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Rep</a:t>
                      </a:r>
                      <a:r>
                        <a:rPr lang="en-CA" baseline="0" dirty="0" smtClean="0"/>
                        <a:t> 1 No. </a:t>
                      </a:r>
                      <a:r>
                        <a:rPr lang="en-CA" baseline="0" dirty="0" err="1" smtClean="0"/>
                        <a:t>Seq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Rep 2 No. </a:t>
                      </a:r>
                      <a:r>
                        <a:rPr lang="en-CA" dirty="0" err="1" smtClean="0"/>
                        <a:t>Seq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Normal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10,250,984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11,351,789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FR</a:t>
                      </a:r>
                      <a:r>
                        <a:rPr lang="en-CA" baseline="0" dirty="0" smtClean="0"/>
                        <a:t> day 2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10,768,153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9,812,613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R day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19,670,689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10,913,067</a:t>
                      </a:r>
                      <a:endParaRPr lang="en-CA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79512" y="3297178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(b)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273329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5447409"/>
              </p:ext>
            </p:extLst>
          </p:nvPr>
        </p:nvGraphicFramePr>
        <p:xfrm>
          <a:off x="683568" y="2298358"/>
          <a:ext cx="7632848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21980"/>
                <a:gridCol w="3005434"/>
                <a:gridCol w="3005434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Light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Quantity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Wavelength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White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~55 </a:t>
                      </a:r>
                      <a:r>
                        <a:rPr lang="en-CA" sz="18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μmol</a:t>
                      </a: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</a:t>
                      </a:r>
                      <a:r>
                        <a:rPr lang="en-CA" sz="1800" kern="1200" baseline="300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2</a:t>
                      </a: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</a:t>
                      </a:r>
                      <a:r>
                        <a:rPr lang="en-CA" sz="1800" kern="1200" baseline="300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1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Red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~15 </a:t>
                      </a:r>
                      <a:r>
                        <a:rPr lang="en-CA" sz="18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μmol</a:t>
                      </a: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</a:t>
                      </a:r>
                      <a:r>
                        <a:rPr lang="en-CA" sz="1800" kern="1200" baseline="300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2</a:t>
                      </a: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</a:t>
                      </a:r>
                      <a:r>
                        <a:rPr lang="en-CA" sz="1800" kern="1200" baseline="300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1</a:t>
                      </a:r>
                      <a:endParaRPr lang="en-CA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dirty="0" smtClean="0"/>
                        <a:t>680 nm</a:t>
                      </a:r>
                      <a:endParaRPr lang="en-CA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Far-red</a:t>
                      </a:r>
                      <a:endParaRPr lang="en-CA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~15 </a:t>
                      </a:r>
                      <a:r>
                        <a:rPr lang="en-CA" sz="18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μmol</a:t>
                      </a: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</a:t>
                      </a:r>
                      <a:r>
                        <a:rPr lang="en-CA" sz="1800" kern="1200" baseline="300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2</a:t>
                      </a:r>
                      <a:r>
                        <a:rPr lang="en-CA" sz="18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</a:t>
                      </a:r>
                      <a:r>
                        <a:rPr lang="en-CA" sz="1800" kern="1200" baseline="300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1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730 nm</a:t>
                      </a:r>
                      <a:endParaRPr lang="en-CA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47664" y="4098558"/>
            <a:ext cx="61206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600" dirty="0" smtClean="0"/>
              <a:t>Table </a:t>
            </a:r>
            <a:r>
              <a:rPr lang="en-CA" sz="1600" dirty="0" smtClean="0"/>
              <a:t>S3. </a:t>
            </a:r>
            <a:r>
              <a:rPr lang="en-GB" sz="1600" dirty="0" smtClean="0"/>
              <a:t>Spectral data of the lamps (</a:t>
            </a:r>
            <a:r>
              <a:rPr lang="en-GB" sz="1600" dirty="0" err="1" smtClean="0"/>
              <a:t>Daina</a:t>
            </a:r>
            <a:r>
              <a:rPr lang="en-GB" sz="1600" dirty="0" smtClean="0"/>
              <a:t> Electronics) used </a:t>
            </a:r>
            <a:r>
              <a:rPr lang="en-GB" sz="1600" dirty="0" smtClean="0"/>
              <a:t>for the different light condition in this study.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1560544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6406609"/>
              </p:ext>
            </p:extLst>
          </p:nvPr>
        </p:nvGraphicFramePr>
        <p:xfrm>
          <a:off x="683568" y="2298358"/>
          <a:ext cx="7632848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21980"/>
                <a:gridCol w="3005434"/>
                <a:gridCol w="3005434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Gene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Forward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dirty="0" smtClean="0"/>
                        <a:t>Reverse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g16251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TGGTGGTGGCCTTCCAGATAT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CCTCGAAACCAGCTTGCTTTA</a:t>
                      </a:r>
                      <a:endParaRPr lang="en-CA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g23648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dirty="0" smtClean="0"/>
                        <a:t>AGGCCTAATTCGCTCAGACAT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dirty="0" smtClean="0"/>
                        <a:t>TGAACCACATCAAAGCCCTTG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dirty="0" smtClean="0"/>
                        <a:t>g290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CGTGGAAGAATCCGACATCAAG</a:t>
                      </a:r>
                      <a:endParaRPr lang="en-CA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CA" dirty="0" smtClean="0"/>
                        <a:t>ATAGCCGCAACGTCTCCTTCAC</a:t>
                      </a:r>
                      <a:endParaRPr lang="en-CA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67544" y="4098558"/>
            <a:ext cx="8218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600" dirty="0" smtClean="0"/>
              <a:t>Table </a:t>
            </a:r>
            <a:r>
              <a:rPr lang="en-CA" sz="1600" dirty="0" smtClean="0"/>
              <a:t>S4. </a:t>
            </a:r>
            <a:r>
              <a:rPr lang="en-GB" sz="1600" dirty="0"/>
              <a:t>Gene specific primers for real-time PCR analysis of gene expression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316238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0125" y="420216"/>
            <a:ext cx="7142163" cy="495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67544" y="5724545"/>
            <a:ext cx="82184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/>
              <a:t>Figure S1. </a:t>
            </a:r>
            <a:r>
              <a:rPr lang="en-GB" sz="1600" dirty="0"/>
              <a:t>Gene Ontology classifications of the set of transcripts in cluster 3 and cluster 11. Relative gene proportions were calculated separately for Biological Process and Molecular Function.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534995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916832" y="467961"/>
            <a:ext cx="3501752" cy="8838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6,099,169 </a:t>
            </a:r>
          </a:p>
          <a:p>
            <a:pPr algn="ctr"/>
            <a:r>
              <a:rPr lang="en-CA" b="1" dirty="0" err="1" smtClean="0">
                <a:solidFill>
                  <a:schemeClr val="tx1"/>
                </a:solidFill>
              </a:rPr>
              <a:t>sRNA</a:t>
            </a:r>
            <a:r>
              <a:rPr lang="en-CA" b="1" dirty="0" smtClean="0">
                <a:solidFill>
                  <a:schemeClr val="tx1"/>
                </a:solidFill>
              </a:rPr>
              <a:t> sequences</a:t>
            </a:r>
            <a:endParaRPr lang="en-CA" b="1" dirty="0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547664" y="2214071"/>
            <a:ext cx="2197968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43.72% </a:t>
            </a:r>
            <a:r>
              <a:rPr lang="en-CA" b="1" dirty="0" err="1" smtClean="0">
                <a:solidFill>
                  <a:schemeClr val="tx1"/>
                </a:solidFill>
              </a:rPr>
              <a:t>Intergenic</a:t>
            </a:r>
            <a:endParaRPr lang="en-CA" b="1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4721424" y="3587159"/>
            <a:ext cx="2312640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38.89% Gene Body</a:t>
            </a:r>
          </a:p>
        </p:txBody>
      </p:sp>
      <p:sp>
        <p:nvSpPr>
          <p:cNvPr id="6" name="Rectangle 5"/>
          <p:cNvSpPr/>
          <p:nvPr/>
        </p:nvSpPr>
        <p:spPr>
          <a:xfrm>
            <a:off x="2245296" y="3596352"/>
            <a:ext cx="2350368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61.11% Promoter</a:t>
            </a:r>
          </a:p>
        </p:txBody>
      </p:sp>
      <p:sp>
        <p:nvSpPr>
          <p:cNvPr id="7" name="Rectangle 6"/>
          <p:cNvSpPr/>
          <p:nvPr/>
        </p:nvSpPr>
        <p:spPr>
          <a:xfrm>
            <a:off x="4116730" y="4860449"/>
            <a:ext cx="1774334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41.40% Intron</a:t>
            </a:r>
          </a:p>
        </p:txBody>
      </p:sp>
      <p:cxnSp>
        <p:nvCxnSpPr>
          <p:cNvPr id="8" name="Straight Arrow Connector 7"/>
          <p:cNvCxnSpPr>
            <a:stCxn id="5" idx="2"/>
            <a:endCxn id="7" idx="0"/>
          </p:cNvCxnSpPr>
          <p:nvPr/>
        </p:nvCxnSpPr>
        <p:spPr>
          <a:xfrm flipH="1">
            <a:off x="5003897" y="4091215"/>
            <a:ext cx="873847" cy="76923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stCxn id="13" idx="2"/>
            <a:endCxn id="5" idx="0"/>
          </p:cNvCxnSpPr>
          <p:nvPr/>
        </p:nvCxnSpPr>
        <p:spPr>
          <a:xfrm>
            <a:off x="4650160" y="2718126"/>
            <a:ext cx="1227584" cy="86903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>
            <a:stCxn id="13" idx="2"/>
            <a:endCxn id="6" idx="0"/>
          </p:cNvCxnSpPr>
          <p:nvPr/>
        </p:nvCxnSpPr>
        <p:spPr>
          <a:xfrm flipH="1">
            <a:off x="3420480" y="2718130"/>
            <a:ext cx="1229680" cy="8782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5877714" y="4860449"/>
            <a:ext cx="1842150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58.60% Exon</a:t>
            </a:r>
          </a:p>
        </p:txBody>
      </p:sp>
      <p:cxnSp>
        <p:nvCxnSpPr>
          <p:cNvPr id="12" name="Straight Arrow Connector 11"/>
          <p:cNvCxnSpPr>
            <a:stCxn id="5" idx="2"/>
            <a:endCxn id="11" idx="0"/>
          </p:cNvCxnSpPr>
          <p:nvPr/>
        </p:nvCxnSpPr>
        <p:spPr>
          <a:xfrm>
            <a:off x="5877748" y="4091215"/>
            <a:ext cx="921045" cy="76923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3714056" y="2214071"/>
            <a:ext cx="1872208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b="1" dirty="0" smtClean="0">
                <a:solidFill>
                  <a:schemeClr val="tx1"/>
                </a:solidFill>
              </a:rPr>
              <a:t>56.28% Genic</a:t>
            </a:r>
            <a:endParaRPr lang="en-CA" b="1" dirty="0">
              <a:solidFill>
                <a:schemeClr val="tx1"/>
              </a:solidFill>
            </a:endParaRPr>
          </a:p>
        </p:txBody>
      </p:sp>
      <p:cxnSp>
        <p:nvCxnSpPr>
          <p:cNvPr id="14" name="Straight Arrow Connector 13"/>
          <p:cNvCxnSpPr>
            <a:stCxn id="3" idx="2"/>
            <a:endCxn id="13" idx="0"/>
          </p:cNvCxnSpPr>
          <p:nvPr/>
        </p:nvCxnSpPr>
        <p:spPr>
          <a:xfrm>
            <a:off x="3667708" y="1351819"/>
            <a:ext cx="982452" cy="86225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3" idx="2"/>
            <a:endCxn id="4" idx="0"/>
          </p:cNvCxnSpPr>
          <p:nvPr/>
        </p:nvCxnSpPr>
        <p:spPr>
          <a:xfrm flipH="1">
            <a:off x="2646648" y="1351819"/>
            <a:ext cx="1021060" cy="86225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67544" y="5724545"/>
            <a:ext cx="821843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/>
              <a:t>Figure S2. The composition of </a:t>
            </a:r>
            <a:r>
              <a:rPr lang="en-CA" sz="1600" dirty="0" err="1"/>
              <a:t>sRNAs</a:t>
            </a:r>
            <a:r>
              <a:rPr lang="en-CA" sz="1600" dirty="0"/>
              <a:t> that mapped to the </a:t>
            </a:r>
            <a:r>
              <a:rPr lang="en-CA" sz="1600" i="1" dirty="0"/>
              <a:t>A. </a:t>
            </a:r>
            <a:r>
              <a:rPr lang="en-CA" sz="1600" i="1" dirty="0" err="1"/>
              <a:t>agallocha</a:t>
            </a:r>
            <a:r>
              <a:rPr lang="en-CA" sz="1600" dirty="0"/>
              <a:t> genome. Only </a:t>
            </a:r>
            <a:r>
              <a:rPr lang="en-CA" sz="1600" dirty="0" err="1"/>
              <a:t>sRNAs</a:t>
            </a:r>
            <a:r>
              <a:rPr lang="en-CA" sz="1600" dirty="0"/>
              <a:t> which mapped perfectly and uniquely to one genome location were retained for analysis.</a:t>
            </a:r>
          </a:p>
        </p:txBody>
      </p:sp>
    </p:spTree>
    <p:extLst>
      <p:ext uri="{BB962C8B-B14F-4D97-AF65-F5344CB8AC3E}">
        <p14:creationId xmlns:p14="http://schemas.microsoft.com/office/powerpoint/2010/main" val="47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0125" y="188640"/>
            <a:ext cx="7142163" cy="495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67544" y="5445224"/>
            <a:ext cx="821843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/>
              <a:t>Figure S3. Gene Ontology classifications of hyper and hypo differentially methylated regions. R</a:t>
            </a:r>
            <a:r>
              <a:rPr lang="en-GB" sz="1600" dirty="0"/>
              <a:t>elative gene proportions were calculated separately for Biological Process and Molecular Function. The set of metabolic process genes containing hypo-methylated regions were curated for secondary metabolic function and </a:t>
            </a:r>
            <a:r>
              <a:rPr lang="en-GB" sz="1600" dirty="0" err="1"/>
              <a:t>sRNA</a:t>
            </a:r>
            <a:r>
              <a:rPr lang="en-GB" sz="1600" dirty="0"/>
              <a:t> which mapped to hypo-DMR regions.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3524427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2" t="3928" r="1501" b="4881"/>
          <a:stretch/>
        </p:blipFill>
        <p:spPr bwMode="auto">
          <a:xfrm>
            <a:off x="1187393" y="116632"/>
            <a:ext cx="1843608" cy="1216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07504" y="476672"/>
            <a:ext cx="8638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1000" b="1" dirty="0" smtClean="0"/>
              <a:t>mRNA</a:t>
            </a:r>
          </a:p>
          <a:p>
            <a:pPr algn="r"/>
            <a:r>
              <a:rPr lang="en-CA" sz="1000" b="1" dirty="0" err="1" smtClean="0"/>
              <a:t>qRT</a:t>
            </a:r>
            <a:r>
              <a:rPr lang="en-CA" sz="1000" b="1" dirty="0" smtClean="0"/>
              <a:t>-PCR</a:t>
            </a:r>
            <a:endParaRPr lang="en-CA" sz="1000" b="1" dirty="0"/>
          </a:p>
        </p:txBody>
      </p:sp>
      <p:pic>
        <p:nvPicPr>
          <p:cNvPr id="1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4" t="3892" r="1739" b="4917"/>
          <a:stretch/>
        </p:blipFill>
        <p:spPr bwMode="auto">
          <a:xfrm>
            <a:off x="3563657" y="116634"/>
            <a:ext cx="1841500" cy="12160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2" t="3892" r="1478" b="4917"/>
          <a:stretch/>
        </p:blipFill>
        <p:spPr bwMode="auto">
          <a:xfrm>
            <a:off x="6011929" y="116633"/>
            <a:ext cx="1838325" cy="1216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763688" y="134195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 smtClean="0"/>
              <a:t>g16251</a:t>
            </a:r>
            <a:endParaRPr lang="en-CA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4211960" y="134195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 smtClean="0"/>
              <a:t>g23648</a:t>
            </a:r>
            <a:endParaRPr lang="en-CA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6660232" y="133266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 smtClean="0"/>
              <a:t>g29032</a:t>
            </a:r>
            <a:endParaRPr lang="en-CA" sz="1200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0557" y="1764708"/>
            <a:ext cx="1819275" cy="1304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3888" y="1764708"/>
            <a:ext cx="1828800" cy="1285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1769843"/>
            <a:ext cx="1819275" cy="1285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-55331" y="2156686"/>
            <a:ext cx="10267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sz="1000" b="1" dirty="0" err="1" smtClean="0"/>
              <a:t>sRNA</a:t>
            </a:r>
            <a:endParaRPr lang="en-CA" sz="1000" b="1" dirty="0" smtClean="0"/>
          </a:p>
          <a:p>
            <a:pPr algn="r"/>
            <a:r>
              <a:rPr lang="en-CA" sz="1000" b="1" dirty="0" err="1" smtClean="0"/>
              <a:t>qRT</a:t>
            </a:r>
            <a:r>
              <a:rPr lang="en-CA" sz="1000" b="1" dirty="0" smtClean="0"/>
              <a:t>-PCR</a:t>
            </a:r>
            <a:endParaRPr lang="en-CA" sz="1000" b="1" dirty="0"/>
          </a:p>
        </p:txBody>
      </p:sp>
      <p:sp>
        <p:nvSpPr>
          <p:cNvPr id="32" name="Rectangle 31"/>
          <p:cNvSpPr/>
          <p:nvPr/>
        </p:nvSpPr>
        <p:spPr>
          <a:xfrm>
            <a:off x="1423939" y="3092790"/>
            <a:ext cx="192392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CA" sz="1000" dirty="0" smtClean="0"/>
              <a:t>TTGGATGTAACTGAGGTATGTGGG</a:t>
            </a:r>
            <a:endParaRPr lang="en-CA" sz="1000" dirty="0">
              <a:cs typeface="Arial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3785903" y="3092790"/>
            <a:ext cx="186621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CA" sz="1000" dirty="0"/>
              <a:t>TTTCTCCAAGGCTAATTAGAAACC</a:t>
            </a:r>
            <a:endParaRPr lang="en-CA" sz="1000" dirty="0">
              <a:cs typeface="Arial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6234175" y="3102663"/>
            <a:ext cx="186621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CA" sz="1000" dirty="0"/>
              <a:t>GTTTGAGCCGTTAACAAATTTCCA</a:t>
            </a:r>
            <a:endParaRPr lang="en-CA" sz="1000" dirty="0"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69424" y="25475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35" name="TextBox 34"/>
          <p:cNvSpPr txBox="1"/>
          <p:nvPr/>
        </p:nvSpPr>
        <p:spPr>
          <a:xfrm>
            <a:off x="4906342" y="255679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36" name="TextBox 35"/>
          <p:cNvSpPr txBox="1"/>
          <p:nvPr/>
        </p:nvSpPr>
        <p:spPr>
          <a:xfrm>
            <a:off x="7340966" y="255679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8" name="TextBox 7"/>
          <p:cNvSpPr txBox="1"/>
          <p:nvPr/>
        </p:nvSpPr>
        <p:spPr>
          <a:xfrm>
            <a:off x="1935000" y="1700808"/>
            <a:ext cx="318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α</a:t>
            </a:r>
            <a:endParaRPr lang="en-CA" sz="1600" dirty="0"/>
          </a:p>
        </p:txBody>
      </p:sp>
      <p:sp>
        <p:nvSpPr>
          <p:cNvPr id="37" name="TextBox 36"/>
          <p:cNvSpPr txBox="1"/>
          <p:nvPr/>
        </p:nvSpPr>
        <p:spPr>
          <a:xfrm>
            <a:off x="4266765" y="1628800"/>
            <a:ext cx="318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α</a:t>
            </a:r>
            <a:endParaRPr lang="en-CA" sz="1600" dirty="0"/>
          </a:p>
        </p:txBody>
      </p:sp>
      <p:sp>
        <p:nvSpPr>
          <p:cNvPr id="38" name="TextBox 37"/>
          <p:cNvSpPr txBox="1"/>
          <p:nvPr/>
        </p:nvSpPr>
        <p:spPr>
          <a:xfrm>
            <a:off x="6715037" y="1656096"/>
            <a:ext cx="318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α</a:t>
            </a:r>
            <a:endParaRPr lang="en-CA" sz="1600" dirty="0"/>
          </a:p>
        </p:txBody>
      </p:sp>
      <p:sp>
        <p:nvSpPr>
          <p:cNvPr id="39" name="TextBox 38"/>
          <p:cNvSpPr txBox="1"/>
          <p:nvPr/>
        </p:nvSpPr>
        <p:spPr>
          <a:xfrm>
            <a:off x="3059832" y="3356992"/>
            <a:ext cx="3384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* N/A. α 2</a:t>
            </a:r>
            <a:r>
              <a:rPr lang="en-GB" sz="1200" baseline="30000" dirty="0"/>
              <a:t>−ΔCT</a:t>
            </a:r>
            <a:r>
              <a:rPr lang="en-GB" sz="1200" dirty="0"/>
              <a:t> (ΔC</a:t>
            </a:r>
            <a:r>
              <a:rPr lang="en-GB" sz="1200" baseline="-25000" dirty="0"/>
              <a:t>T</a:t>
            </a:r>
            <a:r>
              <a:rPr lang="en-GB" sz="1200" dirty="0"/>
              <a:t> = C</a:t>
            </a:r>
            <a:r>
              <a:rPr lang="en-GB" sz="1200" baseline="-25000" dirty="0"/>
              <a:t>T</a:t>
            </a:r>
            <a:r>
              <a:rPr lang="en-GB" sz="1200" dirty="0"/>
              <a:t>, </a:t>
            </a:r>
            <a:r>
              <a:rPr lang="en-GB" sz="1200" dirty="0" smtClean="0"/>
              <a:t>target </a:t>
            </a:r>
            <a:r>
              <a:rPr lang="en-GB" sz="1200" dirty="0"/>
              <a:t>– C</a:t>
            </a:r>
            <a:r>
              <a:rPr lang="en-GB" sz="1200" baseline="-25000" dirty="0"/>
              <a:t>T</a:t>
            </a:r>
            <a:r>
              <a:rPr lang="en-GB" sz="1200" dirty="0"/>
              <a:t>, </a:t>
            </a:r>
            <a:r>
              <a:rPr lang="en-GB" sz="1200" dirty="0" smtClean="0"/>
              <a:t>control)</a:t>
            </a:r>
            <a:endParaRPr lang="en-CA" sz="1200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0194019"/>
              </p:ext>
            </p:extLst>
          </p:nvPr>
        </p:nvGraphicFramePr>
        <p:xfrm>
          <a:off x="323528" y="3717032"/>
          <a:ext cx="8496944" cy="2087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24236"/>
                <a:gridCol w="1908212"/>
                <a:gridCol w="2664296"/>
                <a:gridCol w="18002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smtClean="0"/>
                        <a:t>Gene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smtClean="0"/>
                        <a:t>mRNA</a:t>
                      </a:r>
                      <a:r>
                        <a:rPr lang="en-CA" sz="1600" baseline="0" dirty="0" smtClean="0"/>
                        <a:t> expression </a:t>
                      </a:r>
                    </a:p>
                    <a:p>
                      <a:pPr algn="ctr"/>
                      <a:r>
                        <a:rPr lang="en-CA" sz="1600" baseline="0" dirty="0" smtClean="0"/>
                        <a:t>R / FR (FPKM)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err="1" smtClean="0"/>
                        <a:t>sRNA</a:t>
                      </a:r>
                      <a:r>
                        <a:rPr lang="en-CA" sz="1600" dirty="0" smtClean="0"/>
                        <a:t> sequence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err="1" smtClean="0"/>
                        <a:t>sRNA</a:t>
                      </a:r>
                      <a:r>
                        <a:rPr lang="en-CA" sz="1600" dirty="0" smtClean="0"/>
                        <a:t> expression </a:t>
                      </a:r>
                    </a:p>
                    <a:p>
                      <a:pPr algn="ctr"/>
                      <a:r>
                        <a:rPr lang="en-CA" sz="1600" dirty="0" smtClean="0"/>
                        <a:t>FR / R (TPM)</a:t>
                      </a:r>
                      <a:endParaRPr lang="en-CA" sz="16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sz="1600" dirty="0" smtClean="0"/>
                        <a:t>g16251</a:t>
                      </a:r>
                    </a:p>
                    <a:p>
                      <a:r>
                        <a:rPr lang="en-CA" sz="11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erol </a:t>
                      </a:r>
                      <a:r>
                        <a:rPr lang="en-CA" sz="11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ethytransferase</a:t>
                      </a:r>
                      <a:r>
                        <a:rPr lang="en-CA" sz="11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n-CA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smtClean="0"/>
                        <a:t>1504.45</a:t>
                      </a:r>
                      <a:r>
                        <a:rPr lang="en-CA" sz="1600" baseline="0" dirty="0" smtClean="0"/>
                        <a:t> / 314.19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200" dirty="0" smtClean="0">
                          <a:latin typeface="Courier New" pitchFamily="49" charset="0"/>
                          <a:cs typeface="Courier New" pitchFamily="49" charset="0"/>
                        </a:rPr>
                        <a:t>TTGGATGTAACTGAGGTATGTGGG</a:t>
                      </a:r>
                      <a:endParaRPr lang="en-CA" sz="1200" dirty="0">
                        <a:latin typeface="Courier New" pitchFamily="49" charset="0"/>
                        <a:cs typeface="Courier New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smtClean="0"/>
                        <a:t>0.1217 / 0</a:t>
                      </a:r>
                      <a:endParaRPr lang="en-CA" sz="16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sz="1600" dirty="0" smtClean="0"/>
                        <a:t>g23648</a:t>
                      </a:r>
                    </a:p>
                    <a:p>
                      <a:r>
                        <a:rPr lang="en-CA" sz="110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ydroxysteroid</a:t>
                      </a:r>
                      <a:r>
                        <a:rPr lang="en-CA" sz="11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hydrogenase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smtClean="0"/>
                        <a:t>36.80 / 11.47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200" dirty="0" smtClean="0">
                          <a:latin typeface="Courier New" pitchFamily="49" charset="0"/>
                          <a:cs typeface="Courier New" pitchFamily="49" charset="0"/>
                        </a:rPr>
                        <a:t>TTTCTCCAAGGCTAATTAGAAACC</a:t>
                      </a:r>
                      <a:endParaRPr lang="en-CA" sz="1200" dirty="0">
                        <a:latin typeface="Courier New" pitchFamily="49" charset="0"/>
                        <a:cs typeface="Courier New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600" dirty="0" smtClean="0"/>
                        <a:t>0.1217 / 0</a:t>
                      </a:r>
                      <a:endParaRPr lang="en-CA" sz="16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CA" sz="1600" dirty="0" smtClean="0"/>
                        <a:t>g29032</a:t>
                      </a:r>
                    </a:p>
                    <a:p>
                      <a:r>
                        <a:rPr lang="en-CA" sz="11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ytochrome P450 </a:t>
                      </a:r>
                      <a:endParaRPr lang="en-CA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1600" dirty="0" smtClean="0"/>
                        <a:t>2.55 / 1.67</a:t>
                      </a:r>
                      <a:endParaRPr lang="en-CA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200" dirty="0" smtClean="0">
                          <a:latin typeface="Courier New" pitchFamily="49" charset="0"/>
                          <a:cs typeface="Courier New" pitchFamily="49" charset="0"/>
                        </a:rPr>
                        <a:t>GTTTGAGCCGTTAACAAATTTCCA</a:t>
                      </a:r>
                      <a:endParaRPr lang="en-CA" sz="1200" dirty="0">
                        <a:latin typeface="Courier New" pitchFamily="49" charset="0"/>
                        <a:cs typeface="Courier New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600" dirty="0" smtClean="0"/>
                        <a:t>0.1217 / 0</a:t>
                      </a:r>
                      <a:endParaRPr lang="en-CA" sz="16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467544" y="5910371"/>
            <a:ext cx="82184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/>
              <a:t>Figure S4. </a:t>
            </a:r>
            <a:r>
              <a:rPr lang="en-CA" sz="1600" dirty="0" err="1"/>
              <a:t>qRT</a:t>
            </a:r>
            <a:r>
              <a:rPr lang="en-CA" sz="1600" dirty="0"/>
              <a:t>-PCR validation of mRNA expression and </a:t>
            </a:r>
            <a:r>
              <a:rPr lang="en-CA" sz="1600" dirty="0" err="1"/>
              <a:t>sRNA</a:t>
            </a:r>
            <a:r>
              <a:rPr lang="en-CA" sz="1600" dirty="0"/>
              <a:t> expression. Expression quantification from sequencing data as FPKM and TPM of the mRNA and </a:t>
            </a:r>
            <a:r>
              <a:rPr lang="en-CA" sz="1600" dirty="0" err="1"/>
              <a:t>sRNA</a:t>
            </a:r>
            <a:r>
              <a:rPr lang="en-CA" sz="1600" dirty="0"/>
              <a:t> expression are also shown, respectively</a:t>
            </a:r>
            <a:r>
              <a:rPr lang="en-CA" sz="1600" dirty="0" smtClean="0"/>
              <a:t>.</a:t>
            </a:r>
            <a:endParaRPr lang="en-CA" sz="1600" dirty="0"/>
          </a:p>
        </p:txBody>
      </p:sp>
    </p:spTree>
    <p:extLst>
      <p:ext uri="{BB962C8B-B14F-4D97-AF65-F5344CB8AC3E}">
        <p14:creationId xmlns:p14="http://schemas.microsoft.com/office/powerpoint/2010/main" val="17708212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</TotalTime>
  <Words>390</Words>
  <Application>Microsoft Office PowerPoint</Application>
  <PresentationFormat>On-screen Show (4:3)</PresentationFormat>
  <Paragraphs>106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garwood Slides</dc:title>
  <dc:creator>Tony Kuo</dc:creator>
  <cp:lastModifiedBy>Tony Kuo</cp:lastModifiedBy>
  <cp:revision>92</cp:revision>
  <dcterms:created xsi:type="dcterms:W3CDTF">2014-05-04T12:53:26Z</dcterms:created>
  <dcterms:modified xsi:type="dcterms:W3CDTF">2015-02-28T06:56:37Z</dcterms:modified>
</cp:coreProperties>
</file>